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wmf" ContentType="image/x-wmf"/>
  <Override PartName="/ppt/media/image7.png" ContentType="image/png"/>
  <Override PartName="/ppt/media/image11.wmf" ContentType="image/x-wmf"/>
  <Override PartName="/ppt/media/image8.png" ContentType="image/png"/>
  <Override PartName="/ppt/media/image12.wmf" ContentType="image/x-wmf"/>
  <Override PartName="/ppt/media/image9.wmf" ContentType="image/x-wmf"/>
  <Override PartName="/ppt/media/image10.wmf" ContentType="image/x-wmf"/>
  <Override PartName="/ppt/media/image1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858000" cy="9947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067A51-91B6-4B34-BF2F-163F9A28E9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799C89-2930-418D-A337-C9562857D9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EFF94-2354-4966-8EF6-9D46185902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EA802-BE3A-4054-ABC4-5D601F4E5B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76749-46E0-4CF7-A9C8-FDB41A1135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67711-3E79-4064-8871-A5B2A10ED2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52C70-E1F2-412B-9401-8CBC24F082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03EEE-F605-41CC-9D8F-2103F3D017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257FA-7F29-4E07-9AFE-6EFD4249E8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FF3BC-C93F-4BDC-A19A-1000606293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74648F-9C31-439C-BC97-3412F428C2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E7458-DB3E-4A61-918E-8B90693585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E65B9C-CE2F-4E21-9CFF-E79088DD41A3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7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8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9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0.wmf"/><Relationship Id="rId1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3.wmf"/><Relationship Id="rId7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83760" y="880560"/>
            <a:ext cx="582948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383760" y="2862360"/>
            <a:ext cx="582948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895400" y="2560680"/>
          <a:ext cx="2889360" cy="949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95400" y="2560680"/>
                    <a:ext cx="2889360" cy="9493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1913040" y="5819760"/>
          <a:ext cx="2882880" cy="9748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913040" y="5819760"/>
                    <a:ext cx="2882880" cy="9748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1905120" y="4697280"/>
          <a:ext cx="2889000" cy="10288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905120" y="4697280"/>
                    <a:ext cx="2889000" cy="10288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1895400" y="1504800"/>
          <a:ext cx="2870280" cy="9781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0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895400" y="1504800"/>
                    <a:ext cx="2870280" cy="9781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51" name=""/>
          <p:cNvSpPr/>
          <p:nvPr/>
        </p:nvSpPr>
        <p:spPr>
          <a:xfrm>
            <a:off x="160920" y="2649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1229400" y="1903320"/>
            <a:ext cx="58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RP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741320" y="2033640"/>
            <a:ext cx="7632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974160" y="4024440"/>
            <a:ext cx="84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EGFR-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1762200" y="5278320"/>
            <a:ext cx="5544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974160" y="5145120"/>
            <a:ext cx="84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EGFR-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1762200" y="4162320"/>
            <a:ext cx="5544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1085400" y="6172200"/>
            <a:ext cx="73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1741320" y="6302520"/>
            <a:ext cx="7632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1229400" y="2924280"/>
            <a:ext cx="58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RP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1741320" y="3070080"/>
            <a:ext cx="7632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3971520" y="116352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DU14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1992960" y="1163520"/>
            <a:ext cx="71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HUVE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3339720" y="1163520"/>
            <a:ext cx="61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CH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2781360" y="116352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835880" y="136692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773960" y="176220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15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773960" y="206856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10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773960" y="277956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15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773960" y="308628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10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4773960" y="497844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22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4773960" y="528480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15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774320" y="60339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3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774320" y="630252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3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773960" y="387504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22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773960" y="420696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15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77" name=""/>
          <p:cNvGraphicFramePr/>
          <p:nvPr/>
        </p:nvGraphicFramePr>
        <p:xfrm>
          <a:off x="1908000" y="3606840"/>
          <a:ext cx="2870280" cy="9907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78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1908000" y="3606840"/>
                    <a:ext cx="2870280" cy="9907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514440" y="226008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000000"/>
                </a:solidFill>
                <a:latin typeface="Times New Roman"/>
              </a:rPr>
              <a:t> 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290520" y="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Times New Roman"/>
              </a:rPr>
              <a:t>  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164160" y="4809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176040" y="49658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83" name=""/>
          <p:cNvGraphicFramePr/>
          <p:nvPr/>
        </p:nvGraphicFramePr>
        <p:xfrm>
          <a:off x="3287880" y="5011560"/>
          <a:ext cx="3503520" cy="26625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8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287880" y="5011560"/>
                    <a:ext cx="3503520" cy="2662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5" name=""/>
          <p:cNvGraphicFramePr/>
          <p:nvPr/>
        </p:nvGraphicFramePr>
        <p:xfrm>
          <a:off x="907920" y="5587920"/>
          <a:ext cx="1854360" cy="11048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8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907920" y="5587920"/>
                    <a:ext cx="1854360" cy="11048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87" name=""/>
          <p:cNvGraphicFramePr/>
          <p:nvPr/>
        </p:nvGraphicFramePr>
        <p:xfrm>
          <a:off x="901800" y="6756480"/>
          <a:ext cx="1854000" cy="7873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88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901800" y="6756480"/>
                    <a:ext cx="1854000" cy="7873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pSp>
        <p:nvGrpSpPr>
          <p:cNvPr id="89" name=""/>
          <p:cNvGrpSpPr/>
          <p:nvPr/>
        </p:nvGrpSpPr>
        <p:grpSpPr>
          <a:xfrm>
            <a:off x="248400" y="6005520"/>
            <a:ext cx="591480" cy="276480"/>
            <a:chOff x="248400" y="6005520"/>
            <a:chExt cx="591480" cy="276480"/>
          </a:xfrm>
        </p:grpSpPr>
        <p:sp>
          <p:nvSpPr>
            <p:cNvPr id="90" name=""/>
            <p:cNvSpPr/>
            <p:nvPr/>
          </p:nvSpPr>
          <p:spPr>
            <a:xfrm>
              <a:off x="248400" y="6005520"/>
              <a:ext cx="58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RP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763920" y="6135840"/>
              <a:ext cx="75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92" name=""/>
          <p:cNvGrpSpPr/>
          <p:nvPr/>
        </p:nvGrpSpPr>
        <p:grpSpPr>
          <a:xfrm>
            <a:off x="110520" y="7010280"/>
            <a:ext cx="730800" cy="276480"/>
            <a:chOff x="110520" y="7010280"/>
            <a:chExt cx="730800" cy="276480"/>
          </a:xfrm>
        </p:grpSpPr>
        <p:sp>
          <p:nvSpPr>
            <p:cNvPr id="93" name=""/>
            <p:cNvSpPr/>
            <p:nvPr/>
          </p:nvSpPr>
          <p:spPr>
            <a:xfrm>
              <a:off x="110520" y="7010280"/>
              <a:ext cx="73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765000" y="714060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5" name=""/>
          <p:cNvSpPr/>
          <p:nvPr/>
        </p:nvSpPr>
        <p:spPr>
          <a:xfrm>
            <a:off x="327960" y="529596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1117440" y="5295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1548360" y="52959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#491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2108880" y="52959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#482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99" name=""/>
          <p:cNvGraphicFramePr/>
          <p:nvPr/>
        </p:nvGraphicFramePr>
        <p:xfrm>
          <a:off x="3286080" y="1511280"/>
          <a:ext cx="3409920" cy="22860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00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286080" y="1511280"/>
                    <a:ext cx="3409920" cy="228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1" name=""/>
          <p:cNvGraphicFramePr/>
          <p:nvPr/>
        </p:nvGraphicFramePr>
        <p:xfrm>
          <a:off x="150840" y="1633680"/>
          <a:ext cx="2849400" cy="24476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02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150840" y="1633680"/>
                    <a:ext cx="2849400" cy="2447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3" name=""/>
          <p:cNvSpPr/>
          <p:nvPr/>
        </p:nvSpPr>
        <p:spPr>
          <a:xfrm>
            <a:off x="2716920" y="69357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3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2716920" y="72039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3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2791080" y="550692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2716560" y="582624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15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2716560" y="619596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 10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000000"/>
                </a:solidFill>
                <a:latin typeface="Times New Roman"/>
              </a:rPr>
              <a:t> 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Times New Roman"/>
              </a:rPr>
              <a:t>  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110" name=""/>
          <p:cNvGraphicFramePr/>
          <p:nvPr/>
        </p:nvGraphicFramePr>
        <p:xfrm>
          <a:off x="1119240" y="3535200"/>
          <a:ext cx="4029120" cy="24098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1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19240" y="3535200"/>
                    <a:ext cx="4029120" cy="2409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2" name=""/>
          <p:cNvSpPr/>
          <p:nvPr/>
        </p:nvSpPr>
        <p:spPr>
          <a:xfrm>
            <a:off x="164160" y="4683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113" name=""/>
          <p:cNvGraphicFramePr/>
          <p:nvPr/>
        </p:nvGraphicFramePr>
        <p:xfrm>
          <a:off x="1368360" y="1139760"/>
          <a:ext cx="3333960" cy="22669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368360" y="1139760"/>
                    <a:ext cx="3333960" cy="2266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5" name=""/>
          <p:cNvGraphicFramePr/>
          <p:nvPr/>
        </p:nvGraphicFramePr>
        <p:xfrm>
          <a:off x="1357200" y="6459480"/>
          <a:ext cx="3762360" cy="2219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1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357200" y="6459480"/>
                    <a:ext cx="3762360" cy="221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07-10T09:20:36Z</dcterms:created>
  <dc:creator>Haiyan Jia</dc:creator>
  <dc:description/>
  <dc:language>en-US</dc:language>
  <cp:lastModifiedBy> Haiyen Jia</cp:lastModifiedBy>
  <dcterms:modified xsi:type="dcterms:W3CDTF">2009-11-26T13:46:13Z</dcterms:modified>
  <cp:revision>526</cp:revision>
  <dc:subject/>
  <dc:title>PowerPoint Presentation</dc:title>
</cp:coreProperties>
</file>